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36" d="100"/>
          <a:sy n="136" d="100"/>
        </p:scale>
        <p:origin x="-1688" y="-112"/>
      </p:cViewPr>
      <p:guideLst>
        <p:guide orient="horz" pos="279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309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74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8199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88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500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602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429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192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68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617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5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45B73-869A-1444-A79C-2DEE3084747E}" type="datetimeFigureOut">
              <a:rPr lang="en-US" smtClean="0"/>
              <a:t>12/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DB719-6AA4-064C-91FE-703AB5EADA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45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ontrol.jpe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10" t="13312" r="4836" b="26865"/>
          <a:stretch/>
        </p:blipFill>
        <p:spPr>
          <a:xfrm>
            <a:off x="1298035" y="1094000"/>
            <a:ext cx="5029200" cy="2580104"/>
          </a:xfrm>
          <a:prstGeom prst="rect">
            <a:avLst/>
          </a:prstGeom>
        </p:spPr>
      </p:pic>
      <p:pic>
        <p:nvPicPr>
          <p:cNvPr id="5" name="Picture 4" descr="35b.jpe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084" r="4420" b="16335"/>
          <a:stretch/>
        </p:blipFill>
        <p:spPr>
          <a:xfrm>
            <a:off x="1298035" y="3713656"/>
            <a:ext cx="5029200" cy="2588021"/>
          </a:xfrm>
          <a:prstGeom prst="rect">
            <a:avLst/>
          </a:prstGeom>
        </p:spPr>
      </p:pic>
      <p:pic>
        <p:nvPicPr>
          <p:cNvPr id="6" name="Picture 5" descr="45a.jpe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4" t="12494" r="1206" b="21925"/>
          <a:stretch/>
        </p:blipFill>
        <p:spPr>
          <a:xfrm>
            <a:off x="1298035" y="6343166"/>
            <a:ext cx="5029200" cy="259561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959349" y="782671"/>
            <a:ext cx="10236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Plus Fertilizer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4329921" y="782671"/>
            <a:ext cx="1159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inus Fertilizer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142141" y="2218648"/>
            <a:ext cx="11464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on-transgenic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276080" y="4806559"/>
            <a:ext cx="878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A-8-35b-5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279649" y="7419998"/>
            <a:ext cx="8714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A-8-45a-2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295661" y="143200"/>
            <a:ext cx="62666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dditional file 1. </a:t>
            </a:r>
            <a:r>
              <a:rPr lang="en-US" sz="1200" smtClean="0"/>
              <a:t>Appearances </a:t>
            </a:r>
            <a:r>
              <a:rPr lang="en-US" sz="1200" dirty="0" smtClean="0"/>
              <a:t>of mature kernels from control and transgenic plants grown with and without post-</a:t>
            </a:r>
            <a:r>
              <a:rPr lang="en-US" sz="1200" dirty="0" err="1" smtClean="0"/>
              <a:t>anthesis</a:t>
            </a:r>
            <a:r>
              <a:rPr lang="en-US" sz="1200" dirty="0" smtClean="0"/>
              <a:t> fertilizer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38606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3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RRC, ARS, USD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Altenbach</dc:creator>
  <cp:lastModifiedBy>Susan Altenbach</cp:lastModifiedBy>
  <cp:revision>5</cp:revision>
  <cp:lastPrinted>2014-12-05T00:07:11Z</cp:lastPrinted>
  <dcterms:created xsi:type="dcterms:W3CDTF">2014-12-04T23:54:39Z</dcterms:created>
  <dcterms:modified xsi:type="dcterms:W3CDTF">2014-12-05T02:00:14Z</dcterms:modified>
</cp:coreProperties>
</file>